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98A1D4D-BB30-465A-95C3-E0C35150669E}" v="1" dt="2025-05-07T13:14:12.58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84" d="100"/>
          <a:sy n="84" d="100"/>
        </p:scale>
        <p:origin x="65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E7DC7B-48C8-FD31-8E1C-5581B3DCD3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64A1036-6A15-F238-4F09-971E4DC1CD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581E9F-D1AA-5B21-DABC-8F315AAE5A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07801-5C71-4C1F-9AE2-37D37635CFA4}" type="datetimeFigureOut">
              <a:rPr lang="en-AU" smtClean="0"/>
              <a:t>7/05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A6CFB2-5A65-0256-8198-4C2E0A99A1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69BBDE-AE9B-5877-9A10-97B7A6472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18E87-D00C-487C-BEE1-A63F72F0EE8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14225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979C26-611B-1F64-8E4A-647CE08C6D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6A28932-50DA-2F46-129B-2FF6B63C32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1C0C96-A83B-DE0F-CCF5-625923C214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07801-5C71-4C1F-9AE2-37D37635CFA4}" type="datetimeFigureOut">
              <a:rPr lang="en-AU" smtClean="0"/>
              <a:t>7/05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B2BD12-CA7C-0F26-6195-D156892335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6E5C5F-AEA1-FC67-2129-D89DA53213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18E87-D00C-487C-BEE1-A63F72F0EE8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76496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F87F00F-F5FC-1A5A-58D4-E499C9DF4A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C26FC6-B99D-B52E-39EB-A01F6EFCAA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BBA49E-7A0D-052A-5D0B-E6EF239B21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07801-5C71-4C1F-9AE2-37D37635CFA4}" type="datetimeFigureOut">
              <a:rPr lang="en-AU" smtClean="0"/>
              <a:t>7/05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A14EA8-092F-2993-F165-8642E956CB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6E879F-4472-B179-E85D-770AF39804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18E87-D00C-487C-BEE1-A63F72F0EE8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529742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30DCA-810D-746F-8B2A-A4551AB283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40D5B5-BF25-2A7C-709B-4489E0CEB4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550A7B-C0DD-8F2E-F896-F7116C2914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07801-5C71-4C1F-9AE2-37D37635CFA4}" type="datetimeFigureOut">
              <a:rPr lang="en-AU" smtClean="0"/>
              <a:t>7/05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C23E39-6787-E850-86EF-86E5DCE5B6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6B749C-5F68-503F-4C63-D35FF7A96F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18E87-D00C-487C-BEE1-A63F72F0EE8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99140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8AFDAE-9367-9F37-E750-C10C108AB4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DC5E67-C93F-BB38-A992-2CB6666AE7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0E11AD-4519-EB91-301A-6E7BF682DC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07801-5C71-4C1F-9AE2-37D37635CFA4}" type="datetimeFigureOut">
              <a:rPr lang="en-AU" smtClean="0"/>
              <a:t>7/05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576CA4-2128-443C-1E85-BF54678E31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BA0C61-9E6A-5726-0DBB-BB8E93994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18E87-D00C-487C-BEE1-A63F72F0EE8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07437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37F0BA-87C1-C1E3-1F76-D8C6538274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541018-783C-0216-4DBB-A1B85F66D8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688836-9B38-A578-32B1-0CAA26CF4C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B1548F-2D79-3013-0CB5-F0DCDB1CD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07801-5C71-4C1F-9AE2-37D37635CFA4}" type="datetimeFigureOut">
              <a:rPr lang="en-AU" smtClean="0"/>
              <a:t>7/05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5F829E-8D0C-E4A7-3E69-66D796647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F11AA4-AF9E-3E33-4E2D-759C577BC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18E87-D00C-487C-BEE1-A63F72F0EE8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761923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A896E4-03E5-D097-4BF5-F90C0DD45F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184C79-6E06-AC5C-8994-9C4833B8C2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9FF3DA-CE1E-D272-1DCB-E5C6D59D7C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4CCFB93-809C-8B2A-4D36-073FC2E0450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AF950B0-2213-399B-D36F-0E76457DBF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653956B-5470-A481-BAB1-69511F29A3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07801-5C71-4C1F-9AE2-37D37635CFA4}" type="datetimeFigureOut">
              <a:rPr lang="en-AU" smtClean="0"/>
              <a:t>7/05/2025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3F4500F-1741-2ECE-DAD6-98F1C18555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C9AB742-F070-7FDD-A936-FD38C053B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18E87-D00C-487C-BEE1-A63F72F0EE8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84531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AB6B44-16F9-CDB2-F42B-DD4F8E8C5D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B87645B-D6C5-C7D6-F087-187DAA582F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07801-5C71-4C1F-9AE2-37D37635CFA4}" type="datetimeFigureOut">
              <a:rPr lang="en-AU" smtClean="0"/>
              <a:t>7/05/2025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9FDC026-1FB4-D52E-80D6-B692741C3C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982C699-E259-B326-19BD-D5E932A7C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18E87-D00C-487C-BEE1-A63F72F0EE8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07634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4863D3-D15E-4B7B-AF8F-0D92AB65B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07801-5C71-4C1F-9AE2-37D37635CFA4}" type="datetimeFigureOut">
              <a:rPr lang="en-AU" smtClean="0"/>
              <a:t>7/05/2025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BD7577-B096-3BA1-26C2-2CCBD6F0F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3B48D39-F2DD-5DA6-FA70-9A571389B4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18E87-D00C-487C-BEE1-A63F72F0EE8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01338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F24800-9EF9-9286-69B3-0960A77F5E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E8AE24-2FD5-3537-748D-AAFA023C1D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49EDEE-96F8-98A3-1E14-73925240DC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7307ED2-889E-CC94-4071-8865C07D47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07801-5C71-4C1F-9AE2-37D37635CFA4}" type="datetimeFigureOut">
              <a:rPr lang="en-AU" smtClean="0"/>
              <a:t>7/05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83DD36-C1A8-E441-757A-B5F087A5D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CA032C-DCD6-288A-4B0B-A6F5FAA4B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18E87-D00C-487C-BEE1-A63F72F0EE8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497864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F3FC9E-87B8-6C19-59B4-E21DD0BEF9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01A0E0D-696F-F003-64E0-EC81053BE4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950999-B47F-78D0-0498-35C412DF21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9A2286-E8C2-EA3E-E7C0-6252C3B0F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07801-5C71-4C1F-9AE2-37D37635CFA4}" type="datetimeFigureOut">
              <a:rPr lang="en-AU" smtClean="0"/>
              <a:t>7/05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AC22EE-103D-3C65-F18B-91766FA54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4BF6BF-BBA0-82A7-C1FB-1326175F87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18E87-D00C-487C-BEE1-A63F72F0EE8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08743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BB88C4-6581-0572-8305-A75E35A645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2E8F1A-26CC-7092-1B35-C2BAD125BA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CDFF98-647C-677C-7FBC-A9500B5D08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2B07801-5C71-4C1F-9AE2-37D37635CFA4}" type="datetimeFigureOut">
              <a:rPr lang="en-AU" smtClean="0"/>
              <a:t>7/05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EC861C-B63B-FB59-CAA2-88F781795F8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D81CE1-AA44-80BD-B7FD-34217DC93F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0D18E87-D00C-487C-BEE1-A63F72F0EE8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42704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3675E2B-34BF-5E8F-2550-F71B8DE504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2210" y="366395"/>
            <a:ext cx="4720706" cy="649097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F3AED9D-79EB-9A19-0799-E3455627469F}"/>
              </a:ext>
            </a:extLst>
          </p:cNvPr>
          <p:cNvSpPr txBox="1"/>
          <p:nvPr/>
        </p:nvSpPr>
        <p:spPr>
          <a:xfrm>
            <a:off x="7465650" y="1921256"/>
            <a:ext cx="1536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Cleaved IL-1</a:t>
            </a:r>
            <a:r>
              <a:rPr lang="el-GR" dirty="0"/>
              <a:t>β</a:t>
            </a:r>
            <a:endParaRPr lang="en-AU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F479716-2A18-A791-5600-54EF79882448}"/>
              </a:ext>
            </a:extLst>
          </p:cNvPr>
          <p:cNvSpPr txBox="1"/>
          <p:nvPr/>
        </p:nvSpPr>
        <p:spPr>
          <a:xfrm>
            <a:off x="7244080" y="5323840"/>
            <a:ext cx="1536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Cleaved IL-1</a:t>
            </a:r>
            <a:r>
              <a:rPr lang="el-GR" dirty="0"/>
              <a:t>β</a:t>
            </a:r>
            <a:endParaRPr lang="en-AU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BC24D10-91A9-629E-DC88-90EADFEF545C}"/>
              </a:ext>
            </a:extLst>
          </p:cNvPr>
          <p:cNvSpPr txBox="1"/>
          <p:nvPr/>
        </p:nvSpPr>
        <p:spPr>
          <a:xfrm rot="18265314">
            <a:off x="2727388" y="-116394"/>
            <a:ext cx="9017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uninfecte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1C60320-7496-AA22-955C-D2CB2034B470}"/>
              </a:ext>
            </a:extLst>
          </p:cNvPr>
          <p:cNvSpPr txBox="1"/>
          <p:nvPr/>
        </p:nvSpPr>
        <p:spPr>
          <a:xfrm rot="18265314">
            <a:off x="2936150" y="-238314"/>
            <a:ext cx="12157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/>
              <a:t>S. </a:t>
            </a:r>
            <a:r>
              <a:rPr lang="en-AU" sz="1200" dirty="0"/>
              <a:t>Typhimurium</a:t>
            </a:r>
            <a:endParaRPr lang="en-AU" sz="1200" i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DFC4EB9-4617-20B9-0B8B-7607ACA4FF39}"/>
              </a:ext>
            </a:extLst>
          </p:cNvPr>
          <p:cNvSpPr txBox="1"/>
          <p:nvPr/>
        </p:nvSpPr>
        <p:spPr>
          <a:xfrm rot="18265314">
            <a:off x="3228207" y="-228154"/>
            <a:ext cx="11396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/>
              <a:t>S.</a:t>
            </a:r>
            <a:r>
              <a:rPr lang="en-AU" sz="1200" dirty="0"/>
              <a:t> Dublin ST10</a:t>
            </a:r>
            <a:endParaRPr lang="en-AU" sz="1200" i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F9EEB93-CE17-0110-C913-92963B4191A2}"/>
              </a:ext>
            </a:extLst>
          </p:cNvPr>
          <p:cNvSpPr txBox="1"/>
          <p:nvPr/>
        </p:nvSpPr>
        <p:spPr>
          <a:xfrm rot="18265314">
            <a:off x="3472047" y="-217994"/>
            <a:ext cx="11396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/>
              <a:t>S.</a:t>
            </a:r>
            <a:r>
              <a:rPr lang="en-AU" sz="1200" dirty="0"/>
              <a:t> Dublin ST74</a:t>
            </a:r>
            <a:endParaRPr lang="en-AU" sz="1200" i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1B037C3-81D6-CA34-15B8-8D60A811C204}"/>
              </a:ext>
            </a:extLst>
          </p:cNvPr>
          <p:cNvSpPr txBox="1"/>
          <p:nvPr/>
        </p:nvSpPr>
        <p:spPr>
          <a:xfrm>
            <a:off x="4024187" y="56326"/>
            <a:ext cx="1091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sz="1200" dirty="0" err="1"/>
              <a:t>monophasics</a:t>
            </a:r>
            <a:endParaRPr lang="en-AU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43C64E4-BF1C-B3D9-75A1-EC40EC49DDFD}"/>
              </a:ext>
            </a:extLst>
          </p:cNvPr>
          <p:cNvSpPr txBox="1"/>
          <p:nvPr/>
        </p:nvSpPr>
        <p:spPr>
          <a:xfrm rot="18265314">
            <a:off x="4820348" y="-116394"/>
            <a:ext cx="9017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uninfecte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1F436E0-30BD-CDD6-A9AC-9EB7A7318A50}"/>
              </a:ext>
            </a:extLst>
          </p:cNvPr>
          <p:cNvSpPr txBox="1"/>
          <p:nvPr/>
        </p:nvSpPr>
        <p:spPr>
          <a:xfrm rot="18265314">
            <a:off x="5029110" y="-238314"/>
            <a:ext cx="12157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/>
              <a:t>S. </a:t>
            </a:r>
            <a:r>
              <a:rPr lang="en-AU" sz="1200" dirty="0"/>
              <a:t>Typhimurium</a:t>
            </a:r>
            <a:endParaRPr lang="en-AU" sz="1200" i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A08FFD6-A3DC-2B33-28E6-36558872283E}"/>
              </a:ext>
            </a:extLst>
          </p:cNvPr>
          <p:cNvSpPr txBox="1"/>
          <p:nvPr/>
        </p:nvSpPr>
        <p:spPr>
          <a:xfrm rot="18265314">
            <a:off x="5321167" y="-228154"/>
            <a:ext cx="11396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/>
              <a:t>S.</a:t>
            </a:r>
            <a:r>
              <a:rPr lang="en-AU" sz="1200" dirty="0"/>
              <a:t> Dublin ST10</a:t>
            </a:r>
            <a:endParaRPr lang="en-AU" sz="1200" i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0DE5733-B008-62E3-D8AC-B75160769938}"/>
              </a:ext>
            </a:extLst>
          </p:cNvPr>
          <p:cNvSpPr txBox="1"/>
          <p:nvPr/>
        </p:nvSpPr>
        <p:spPr>
          <a:xfrm rot="18265314">
            <a:off x="5565007" y="-217994"/>
            <a:ext cx="11396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/>
              <a:t>S.</a:t>
            </a:r>
            <a:r>
              <a:rPr lang="en-AU" sz="1200" dirty="0"/>
              <a:t> Dublin ST74</a:t>
            </a:r>
            <a:endParaRPr lang="en-AU" sz="1200" i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0A4094-E793-6AB9-F75B-29AA7D3EE45B}"/>
              </a:ext>
            </a:extLst>
          </p:cNvPr>
          <p:cNvSpPr txBox="1"/>
          <p:nvPr/>
        </p:nvSpPr>
        <p:spPr>
          <a:xfrm>
            <a:off x="6117147" y="56326"/>
            <a:ext cx="1091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sz="1200" dirty="0" err="1"/>
              <a:t>monophasics</a:t>
            </a:r>
            <a:endParaRPr lang="en-AU" sz="12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9D165A3-1E63-8125-B657-19B3729B8F7A}"/>
              </a:ext>
            </a:extLst>
          </p:cNvPr>
          <p:cNvSpPr txBox="1"/>
          <p:nvPr/>
        </p:nvSpPr>
        <p:spPr>
          <a:xfrm>
            <a:off x="3605502" y="2682240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0 hpi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181E6067-6DC7-F4CD-A396-521C6A924BE7}"/>
              </a:ext>
            </a:extLst>
          </p:cNvPr>
          <p:cNvCxnSpPr>
            <a:cxnSpLocks/>
          </p:cNvCxnSpPr>
          <p:nvPr/>
        </p:nvCxnSpPr>
        <p:spPr>
          <a:xfrm>
            <a:off x="4994163" y="366395"/>
            <a:ext cx="9534" cy="29254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DC166DC5-B0FA-2321-4AE5-15E93EB618C7}"/>
              </a:ext>
            </a:extLst>
          </p:cNvPr>
          <p:cNvSpPr txBox="1"/>
          <p:nvPr/>
        </p:nvSpPr>
        <p:spPr>
          <a:xfrm>
            <a:off x="5739102" y="2682240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3 hpi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C72F8E7-EE8F-7525-E93E-1B985057BFE8}"/>
              </a:ext>
            </a:extLst>
          </p:cNvPr>
          <p:cNvSpPr txBox="1"/>
          <p:nvPr/>
        </p:nvSpPr>
        <p:spPr>
          <a:xfrm>
            <a:off x="3605502" y="5882640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9 hpi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591B66D-41AF-3A75-7FD1-2BFAEE028CCE}"/>
              </a:ext>
            </a:extLst>
          </p:cNvPr>
          <p:cNvSpPr txBox="1"/>
          <p:nvPr/>
        </p:nvSpPr>
        <p:spPr>
          <a:xfrm>
            <a:off x="5739102" y="5882640"/>
            <a:ext cx="788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24 hpi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75DFF086-7DFA-CFA7-9D2D-57F8329FFDE4}"/>
              </a:ext>
            </a:extLst>
          </p:cNvPr>
          <p:cNvCxnSpPr>
            <a:cxnSpLocks/>
          </p:cNvCxnSpPr>
          <p:nvPr/>
        </p:nvCxnSpPr>
        <p:spPr>
          <a:xfrm>
            <a:off x="4780803" y="3383915"/>
            <a:ext cx="9534" cy="29254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AA4850A8-1C64-39E8-26A4-0A33E22E5D7A}"/>
              </a:ext>
            </a:extLst>
          </p:cNvPr>
          <p:cNvCxnSpPr>
            <a:stCxn id="6" idx="1"/>
          </p:cNvCxnSpPr>
          <p:nvPr/>
        </p:nvCxnSpPr>
        <p:spPr>
          <a:xfrm flipH="1">
            <a:off x="7149674" y="2105922"/>
            <a:ext cx="315976" cy="2463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3C7EF7BA-8A07-031F-A36E-DE912D55EE01}"/>
              </a:ext>
            </a:extLst>
          </p:cNvPr>
          <p:cNvCxnSpPr/>
          <p:nvPr/>
        </p:nvCxnSpPr>
        <p:spPr>
          <a:xfrm flipH="1">
            <a:off x="6991686" y="5540526"/>
            <a:ext cx="315976" cy="2463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64895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0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ebecca Ambrose</dc:creator>
  <cp:lastModifiedBy>Jaclyn Pearson</cp:lastModifiedBy>
  <cp:revision>3</cp:revision>
  <dcterms:created xsi:type="dcterms:W3CDTF">2025-05-07T09:13:14Z</dcterms:created>
  <dcterms:modified xsi:type="dcterms:W3CDTF">2025-05-07T13:56:49Z</dcterms:modified>
</cp:coreProperties>
</file>